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sldIdLst>
    <p:sldId id="257" r:id="rId2"/>
  </p:sldIdLst>
  <p:sldSz cx="9720263" cy="10080625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02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3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9020" y="1649770"/>
            <a:ext cx="8262224" cy="3509551"/>
          </a:xfrm>
        </p:spPr>
        <p:txBody>
          <a:bodyPr anchor="b"/>
          <a:lstStyle>
            <a:lvl1pPr algn="ctr">
              <a:defRPr sz="637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5033" y="5294662"/>
            <a:ext cx="7290197" cy="2433817"/>
          </a:xfrm>
        </p:spPr>
        <p:txBody>
          <a:bodyPr/>
          <a:lstStyle>
            <a:lvl1pPr marL="0" indent="0" algn="ctr">
              <a:buNone/>
              <a:defRPr sz="2551"/>
            </a:lvl1pPr>
            <a:lvl2pPr marL="486004" indent="0" algn="ctr">
              <a:buNone/>
              <a:defRPr sz="2126"/>
            </a:lvl2pPr>
            <a:lvl3pPr marL="972007" indent="0" algn="ctr">
              <a:buNone/>
              <a:defRPr sz="1913"/>
            </a:lvl3pPr>
            <a:lvl4pPr marL="1458011" indent="0" algn="ctr">
              <a:buNone/>
              <a:defRPr sz="1701"/>
            </a:lvl4pPr>
            <a:lvl5pPr marL="1944014" indent="0" algn="ctr">
              <a:buNone/>
              <a:defRPr sz="1701"/>
            </a:lvl5pPr>
            <a:lvl6pPr marL="2430018" indent="0" algn="ctr">
              <a:buNone/>
              <a:defRPr sz="1701"/>
            </a:lvl6pPr>
            <a:lvl7pPr marL="2916022" indent="0" algn="ctr">
              <a:buNone/>
              <a:defRPr sz="1701"/>
            </a:lvl7pPr>
            <a:lvl8pPr marL="3402025" indent="0" algn="ctr">
              <a:buNone/>
              <a:defRPr sz="1701"/>
            </a:lvl8pPr>
            <a:lvl9pPr marL="3888029" indent="0" algn="ctr">
              <a:buNone/>
              <a:defRPr sz="170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06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970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56064" y="536700"/>
            <a:ext cx="2095932" cy="854286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8269" y="536700"/>
            <a:ext cx="6166292" cy="854286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636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336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3206" y="2513159"/>
            <a:ext cx="8383727" cy="4193259"/>
          </a:xfrm>
        </p:spPr>
        <p:txBody>
          <a:bodyPr anchor="b"/>
          <a:lstStyle>
            <a:lvl1pPr>
              <a:defRPr sz="637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3206" y="6746088"/>
            <a:ext cx="8383727" cy="2205136"/>
          </a:xfrm>
        </p:spPr>
        <p:txBody>
          <a:bodyPr/>
          <a:lstStyle>
            <a:lvl1pPr marL="0" indent="0">
              <a:buNone/>
              <a:defRPr sz="2551">
                <a:solidFill>
                  <a:schemeClr val="tx1"/>
                </a:solidFill>
              </a:defRPr>
            </a:lvl1pPr>
            <a:lvl2pPr marL="486004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2pPr>
            <a:lvl3pPr marL="972007" indent="0">
              <a:buNone/>
              <a:defRPr sz="1913">
                <a:solidFill>
                  <a:schemeClr val="tx1">
                    <a:tint val="75000"/>
                  </a:schemeClr>
                </a:solidFill>
              </a:defRPr>
            </a:lvl3pPr>
            <a:lvl4pPr marL="1458011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4pPr>
            <a:lvl5pPr marL="1944014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5pPr>
            <a:lvl6pPr marL="243001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6pPr>
            <a:lvl7pPr marL="2916022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7pPr>
            <a:lvl8pPr marL="3402025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8pPr>
            <a:lvl9pPr marL="3888029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030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8268" y="2683500"/>
            <a:ext cx="4131112" cy="63960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20883" y="2683500"/>
            <a:ext cx="4131112" cy="63960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89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536702"/>
            <a:ext cx="8383727" cy="194845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9535" y="2471154"/>
            <a:ext cx="4112126" cy="1211074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9535" y="3682228"/>
            <a:ext cx="4112126" cy="541600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20884" y="2471154"/>
            <a:ext cx="4132378" cy="1211074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20884" y="3682228"/>
            <a:ext cx="4132378" cy="541600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710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267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194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672042"/>
            <a:ext cx="3135038" cy="2352146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32378" y="1451426"/>
            <a:ext cx="4920883" cy="7163777"/>
          </a:xfrm>
        </p:spPr>
        <p:txBody>
          <a:bodyPr/>
          <a:lstStyle>
            <a:lvl1pPr>
              <a:defRPr sz="3402"/>
            </a:lvl1pPr>
            <a:lvl2pPr>
              <a:defRPr sz="2976"/>
            </a:lvl2pPr>
            <a:lvl3pPr>
              <a:defRPr sz="2551"/>
            </a:lvl3pPr>
            <a:lvl4pPr>
              <a:defRPr sz="2126"/>
            </a:lvl4pPr>
            <a:lvl5pPr>
              <a:defRPr sz="2126"/>
            </a:lvl5pPr>
            <a:lvl6pPr>
              <a:defRPr sz="2126"/>
            </a:lvl6pPr>
            <a:lvl7pPr>
              <a:defRPr sz="2126"/>
            </a:lvl7pPr>
            <a:lvl8pPr>
              <a:defRPr sz="2126"/>
            </a:lvl8pPr>
            <a:lvl9pPr>
              <a:defRPr sz="2126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3024188"/>
            <a:ext cx="3135038" cy="5602681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4799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672042"/>
            <a:ext cx="3135038" cy="2352146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32378" y="1451426"/>
            <a:ext cx="4920883" cy="7163777"/>
          </a:xfrm>
        </p:spPr>
        <p:txBody>
          <a:bodyPr anchor="t"/>
          <a:lstStyle>
            <a:lvl1pPr marL="0" indent="0">
              <a:buNone/>
              <a:defRPr sz="3402"/>
            </a:lvl1pPr>
            <a:lvl2pPr marL="486004" indent="0">
              <a:buNone/>
              <a:defRPr sz="2976"/>
            </a:lvl2pPr>
            <a:lvl3pPr marL="972007" indent="0">
              <a:buNone/>
              <a:defRPr sz="2551"/>
            </a:lvl3pPr>
            <a:lvl4pPr marL="1458011" indent="0">
              <a:buNone/>
              <a:defRPr sz="2126"/>
            </a:lvl4pPr>
            <a:lvl5pPr marL="1944014" indent="0">
              <a:buNone/>
              <a:defRPr sz="2126"/>
            </a:lvl5pPr>
            <a:lvl6pPr marL="2430018" indent="0">
              <a:buNone/>
              <a:defRPr sz="2126"/>
            </a:lvl6pPr>
            <a:lvl7pPr marL="2916022" indent="0">
              <a:buNone/>
              <a:defRPr sz="2126"/>
            </a:lvl7pPr>
            <a:lvl8pPr marL="3402025" indent="0">
              <a:buNone/>
              <a:defRPr sz="2126"/>
            </a:lvl8pPr>
            <a:lvl9pPr marL="3888029" indent="0">
              <a:buNone/>
              <a:defRPr sz="212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3024188"/>
            <a:ext cx="3135038" cy="5602681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128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8268" y="536702"/>
            <a:ext cx="8383727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8268" y="2683500"/>
            <a:ext cx="8383727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8268" y="9343248"/>
            <a:ext cx="218705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FDC17-F203-4604-91F4-F09B11AF1B24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19837" y="9343248"/>
            <a:ext cx="328058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64936" y="9343248"/>
            <a:ext cx="218705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EE90A-0220-44F4-AE69-C06EC076F2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237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972007" rtl="0" eaLnBrk="1" latinLnBrk="0" hangingPunct="1">
        <a:lnSpc>
          <a:spcPct val="90000"/>
        </a:lnSpc>
        <a:spcBef>
          <a:spcPct val="0"/>
        </a:spcBef>
        <a:buNone/>
        <a:defRPr sz="46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02" indent="-243002" algn="l" defTabSz="972007" rtl="0" eaLnBrk="1" latinLnBrk="0" hangingPunct="1">
        <a:lnSpc>
          <a:spcPct val="90000"/>
        </a:lnSpc>
        <a:spcBef>
          <a:spcPts val="1063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29005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15009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70101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2187016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673020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315902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645027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4131031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1pPr>
      <a:lvl2pPr marL="48600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2pPr>
      <a:lvl3pPr marL="972007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3pPr>
      <a:lvl4pPr marL="1458011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194401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430018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2916022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402025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3888029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C570803C-5EAA-4930-B915-2981451BC1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5721951"/>
              </p:ext>
            </p:extLst>
          </p:nvPr>
        </p:nvGraphicFramePr>
        <p:xfrm>
          <a:off x="331290" y="685319"/>
          <a:ext cx="2387600" cy="120015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65383">
                  <a:extLst>
                    <a:ext uri="{9D8B030D-6E8A-4147-A177-3AD203B41FA5}">
                      <a16:colId xmlns:a16="http://schemas.microsoft.com/office/drawing/2014/main" val="2338167845"/>
                    </a:ext>
                  </a:extLst>
                </a:gridCol>
                <a:gridCol w="1322217">
                  <a:extLst>
                    <a:ext uri="{9D8B030D-6E8A-4147-A177-3AD203B41FA5}">
                      <a16:colId xmlns:a16="http://schemas.microsoft.com/office/drawing/2014/main" val="1151140658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nt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undanc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4010121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1 ACGU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43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857342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2 ACCG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72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6498925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3 CACA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8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653792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4 AUGG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74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4007236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5 ACUG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52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1348473"/>
                  </a:ext>
                </a:extLst>
              </a:tr>
            </a:tbl>
          </a:graphicData>
        </a:graphic>
      </p:graphicFrame>
      <p:sp>
        <p:nvSpPr>
          <p:cNvPr id="6" name="TextBox 6">
            <a:extLst>
              <a:ext uri="{FF2B5EF4-FFF2-40B4-BE49-F238E27FC236}">
                <a16:creationId xmlns:a16="http://schemas.microsoft.com/office/drawing/2014/main" id="{5D3A2B96-884C-425D-98FE-2238830BA4CA}"/>
              </a:ext>
            </a:extLst>
          </p:cNvPr>
          <p:cNvSpPr txBox="1"/>
          <p:nvPr/>
        </p:nvSpPr>
        <p:spPr>
          <a:xfrm>
            <a:off x="0" y="0"/>
            <a:ext cx="37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7">
            <a:extLst>
              <a:ext uri="{FF2B5EF4-FFF2-40B4-BE49-F238E27FC236}">
                <a16:creationId xmlns:a16="http://schemas.microsoft.com/office/drawing/2014/main" id="{D45A29FD-A534-4189-B1CF-19DFA79C03EE}"/>
              </a:ext>
            </a:extLst>
          </p:cNvPr>
          <p:cNvSpPr txBox="1"/>
          <p:nvPr/>
        </p:nvSpPr>
        <p:spPr>
          <a:xfrm>
            <a:off x="3063948" y="0"/>
            <a:ext cx="415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8">
            <a:extLst>
              <a:ext uri="{FF2B5EF4-FFF2-40B4-BE49-F238E27FC236}">
                <a16:creationId xmlns:a16="http://schemas.microsoft.com/office/drawing/2014/main" id="{78404AB9-2D02-4FFF-AA13-68A462B008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0167286"/>
              </p:ext>
            </p:extLst>
          </p:nvPr>
        </p:nvGraphicFramePr>
        <p:xfrm>
          <a:off x="3383518" y="705523"/>
          <a:ext cx="2387600" cy="120015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65383">
                  <a:extLst>
                    <a:ext uri="{9D8B030D-6E8A-4147-A177-3AD203B41FA5}">
                      <a16:colId xmlns:a16="http://schemas.microsoft.com/office/drawing/2014/main" val="2338167845"/>
                    </a:ext>
                  </a:extLst>
                </a:gridCol>
                <a:gridCol w="1322217">
                  <a:extLst>
                    <a:ext uri="{9D8B030D-6E8A-4147-A177-3AD203B41FA5}">
                      <a16:colId xmlns:a16="http://schemas.microsoft.com/office/drawing/2014/main" val="1151140658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nt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undanc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4010121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6 GUUG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857342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7 UCAA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6498925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8 UUGA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653792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9 UCGC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4007236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-10 UCAA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1348473"/>
                  </a:ext>
                </a:extLst>
              </a:tr>
            </a:tbl>
          </a:graphicData>
        </a:graphic>
      </p:graphicFrame>
      <p:sp>
        <p:nvSpPr>
          <p:cNvPr id="9" name="TextBox 9">
            <a:extLst>
              <a:ext uri="{FF2B5EF4-FFF2-40B4-BE49-F238E27FC236}">
                <a16:creationId xmlns:a16="http://schemas.microsoft.com/office/drawing/2014/main" id="{DDE86ECE-A013-4C2E-924C-31B10CE1538A}"/>
              </a:ext>
            </a:extLst>
          </p:cNvPr>
          <p:cNvSpPr txBox="1"/>
          <p:nvPr/>
        </p:nvSpPr>
        <p:spPr>
          <a:xfrm>
            <a:off x="444447" y="319159"/>
            <a:ext cx="2161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ve most abundant motifs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1B79CA29-5B20-48D5-8F7E-A7B593D07CA0}"/>
              </a:ext>
            </a:extLst>
          </p:cNvPr>
          <p:cNvSpPr txBox="1"/>
          <p:nvPr/>
        </p:nvSpPr>
        <p:spPr>
          <a:xfrm>
            <a:off x="3496667" y="319159"/>
            <a:ext cx="2161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ve least abundant motifs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5388536D-8AA1-4697-ACF6-CC17306BDA74}"/>
              </a:ext>
            </a:extLst>
          </p:cNvPr>
          <p:cNvGrpSpPr/>
          <p:nvPr/>
        </p:nvGrpSpPr>
        <p:grpSpPr>
          <a:xfrm>
            <a:off x="187036" y="2570788"/>
            <a:ext cx="9143843" cy="4440712"/>
            <a:chOff x="225215" y="2944009"/>
            <a:chExt cx="7437785" cy="3401513"/>
          </a:xfrm>
        </p:grpSpPr>
        <p:pic>
          <p:nvPicPr>
            <p:cNvPr id="11" name="Picture 39">
              <a:extLst>
                <a:ext uri="{FF2B5EF4-FFF2-40B4-BE49-F238E27FC236}">
                  <a16:creationId xmlns:a16="http://schemas.microsoft.com/office/drawing/2014/main" id="{B42425EB-7729-4291-B256-38155EEB1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5215" y="2944009"/>
              <a:ext cx="7437785" cy="1212084"/>
            </a:xfrm>
            <a:prstGeom prst="rect">
              <a:avLst/>
            </a:prstGeom>
          </p:spPr>
        </p:pic>
        <p:sp>
          <p:nvSpPr>
            <p:cNvPr id="12" name="Rectangle 40">
              <a:extLst>
                <a:ext uri="{FF2B5EF4-FFF2-40B4-BE49-F238E27FC236}">
                  <a16:creationId xmlns:a16="http://schemas.microsoft.com/office/drawing/2014/main" id="{25E9C4C4-ED4E-4DC8-A139-0C78B6CF5125}"/>
                </a:ext>
              </a:extLst>
            </p:cNvPr>
            <p:cNvSpPr/>
            <p:nvPr/>
          </p:nvSpPr>
          <p:spPr>
            <a:xfrm>
              <a:off x="684615" y="4136055"/>
              <a:ext cx="678297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1-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41">
              <a:extLst>
                <a:ext uri="{FF2B5EF4-FFF2-40B4-BE49-F238E27FC236}">
                  <a16:creationId xmlns:a16="http://schemas.microsoft.com/office/drawing/2014/main" id="{E16DBBEA-F711-4F09-A2B6-A172AA6B96A0}"/>
                </a:ext>
              </a:extLst>
            </p:cNvPr>
            <p:cNvSpPr/>
            <p:nvPr/>
          </p:nvSpPr>
          <p:spPr>
            <a:xfrm>
              <a:off x="2142910" y="4136054"/>
              <a:ext cx="678297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1-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42">
              <a:extLst>
                <a:ext uri="{FF2B5EF4-FFF2-40B4-BE49-F238E27FC236}">
                  <a16:creationId xmlns:a16="http://schemas.microsoft.com/office/drawing/2014/main" id="{9EAA998F-F3A3-404D-AD6A-0735DF02D747}"/>
                </a:ext>
              </a:extLst>
            </p:cNvPr>
            <p:cNvSpPr/>
            <p:nvPr/>
          </p:nvSpPr>
          <p:spPr>
            <a:xfrm>
              <a:off x="3432239" y="4136053"/>
              <a:ext cx="643091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1-mut 3</a:t>
              </a:r>
              <a:endPara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43">
              <a:extLst>
                <a:ext uri="{FF2B5EF4-FFF2-40B4-BE49-F238E27FC236}">
                  <a16:creationId xmlns:a16="http://schemas.microsoft.com/office/drawing/2014/main" id="{A651534C-1574-4CC2-9912-640EA33D9469}"/>
                </a:ext>
              </a:extLst>
            </p:cNvPr>
            <p:cNvSpPr/>
            <p:nvPr/>
          </p:nvSpPr>
          <p:spPr>
            <a:xfrm>
              <a:off x="4868337" y="4136053"/>
              <a:ext cx="678297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1-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  <a:endPara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44">
              <a:extLst>
                <a:ext uri="{FF2B5EF4-FFF2-40B4-BE49-F238E27FC236}">
                  <a16:creationId xmlns:a16="http://schemas.microsoft.com/office/drawing/2014/main" id="{434FF308-410C-41CB-921E-F4948D90FF97}"/>
                </a:ext>
              </a:extLst>
            </p:cNvPr>
            <p:cNvSpPr/>
            <p:nvPr/>
          </p:nvSpPr>
          <p:spPr>
            <a:xfrm>
              <a:off x="6430142" y="4136052"/>
              <a:ext cx="678297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L1- </a:t>
              </a:r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  <a:endParaRPr lang="en-GB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46">
              <a:extLst>
                <a:ext uri="{FF2B5EF4-FFF2-40B4-BE49-F238E27FC236}">
                  <a16:creationId xmlns:a16="http://schemas.microsoft.com/office/drawing/2014/main" id="{7B433C8E-A8B3-414B-A6FF-14B7DB8A1E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6989" y="4637807"/>
              <a:ext cx="6995611" cy="1565863"/>
            </a:xfrm>
            <a:prstGeom prst="rect">
              <a:avLst/>
            </a:prstGeom>
          </p:spPr>
        </p:pic>
        <p:sp>
          <p:nvSpPr>
            <p:cNvPr id="18" name="Rectangle 47">
              <a:extLst>
                <a:ext uri="{FF2B5EF4-FFF2-40B4-BE49-F238E27FC236}">
                  <a16:creationId xmlns:a16="http://schemas.microsoft.com/office/drawing/2014/main" id="{A686BFBA-8172-42E6-9062-E3701EEF7782}"/>
                </a:ext>
              </a:extLst>
            </p:cNvPr>
            <p:cNvSpPr/>
            <p:nvPr/>
          </p:nvSpPr>
          <p:spPr>
            <a:xfrm>
              <a:off x="715267" y="6133345"/>
              <a:ext cx="643091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-mut 6</a:t>
              </a:r>
            </a:p>
          </p:txBody>
        </p:sp>
        <p:sp>
          <p:nvSpPr>
            <p:cNvPr id="19" name="Rectangle 48">
              <a:extLst>
                <a:ext uri="{FF2B5EF4-FFF2-40B4-BE49-F238E27FC236}">
                  <a16:creationId xmlns:a16="http://schemas.microsoft.com/office/drawing/2014/main" id="{A370A5C7-EB82-4B73-800E-F96990FCE5D9}"/>
                </a:ext>
              </a:extLst>
            </p:cNvPr>
            <p:cNvSpPr/>
            <p:nvPr/>
          </p:nvSpPr>
          <p:spPr>
            <a:xfrm>
              <a:off x="2169105" y="6133344"/>
              <a:ext cx="643091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-mut 7</a:t>
              </a:r>
            </a:p>
          </p:txBody>
        </p:sp>
        <p:sp>
          <p:nvSpPr>
            <p:cNvPr id="20" name="Rectangle 49">
              <a:extLst>
                <a:ext uri="{FF2B5EF4-FFF2-40B4-BE49-F238E27FC236}">
                  <a16:creationId xmlns:a16="http://schemas.microsoft.com/office/drawing/2014/main" id="{377F9D64-0F82-4350-83C8-0317AC326776}"/>
                </a:ext>
              </a:extLst>
            </p:cNvPr>
            <p:cNvSpPr/>
            <p:nvPr/>
          </p:nvSpPr>
          <p:spPr>
            <a:xfrm>
              <a:off x="3604949" y="6133343"/>
              <a:ext cx="678297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- </a:t>
              </a:r>
              <a:r>
                <a:rPr lang="en-GB" sz="12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8</a:t>
              </a:r>
            </a:p>
          </p:txBody>
        </p:sp>
        <p:sp>
          <p:nvSpPr>
            <p:cNvPr id="21" name="Rectangle 50">
              <a:extLst>
                <a:ext uri="{FF2B5EF4-FFF2-40B4-BE49-F238E27FC236}">
                  <a16:creationId xmlns:a16="http://schemas.microsoft.com/office/drawing/2014/main" id="{86BEEC10-5AA0-43D5-83A8-81EF7D4C1E33}"/>
                </a:ext>
              </a:extLst>
            </p:cNvPr>
            <p:cNvSpPr/>
            <p:nvPr/>
          </p:nvSpPr>
          <p:spPr>
            <a:xfrm>
              <a:off x="5066083" y="6124981"/>
              <a:ext cx="643091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-mut 9</a:t>
              </a:r>
            </a:p>
          </p:txBody>
        </p:sp>
        <p:sp>
          <p:nvSpPr>
            <p:cNvPr id="22" name="Rectangle 51">
              <a:extLst>
                <a:ext uri="{FF2B5EF4-FFF2-40B4-BE49-F238E27FC236}">
                  <a16:creationId xmlns:a16="http://schemas.microsoft.com/office/drawing/2014/main" id="{D5A0C64F-EE2C-4A92-AF55-1DACE1002DD7}"/>
                </a:ext>
              </a:extLst>
            </p:cNvPr>
            <p:cNvSpPr/>
            <p:nvPr/>
          </p:nvSpPr>
          <p:spPr>
            <a:xfrm>
              <a:off x="6413192" y="6124980"/>
              <a:ext cx="712198" cy="2121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-mut 10</a:t>
              </a:r>
            </a:p>
          </p:txBody>
        </p:sp>
      </p:grpSp>
      <p:sp>
        <p:nvSpPr>
          <p:cNvPr id="26" name="TextBox 7">
            <a:extLst>
              <a:ext uri="{FF2B5EF4-FFF2-40B4-BE49-F238E27FC236}">
                <a16:creationId xmlns:a16="http://schemas.microsoft.com/office/drawing/2014/main" id="{A0FA7D1B-3BEF-478C-A3A7-9E33411924DB}"/>
              </a:ext>
            </a:extLst>
          </p:cNvPr>
          <p:cNvSpPr txBox="1"/>
          <p:nvPr/>
        </p:nvSpPr>
        <p:spPr>
          <a:xfrm>
            <a:off x="0" y="2201456"/>
            <a:ext cx="618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B694A005-6012-474B-A440-1890A5844EA5}"/>
              </a:ext>
            </a:extLst>
          </p:cNvPr>
          <p:cNvSpPr txBox="1"/>
          <p:nvPr/>
        </p:nvSpPr>
        <p:spPr>
          <a:xfrm>
            <a:off x="26161" y="4597393"/>
            <a:ext cx="321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Rectangle 2"/>
          <p:cNvSpPr/>
          <p:nvPr/>
        </p:nvSpPr>
        <p:spPr>
          <a:xfrm>
            <a:off x="93505" y="7204355"/>
            <a:ext cx="9330879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200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GB" sz="1200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le </a:t>
            </a:r>
            <a:r>
              <a:rPr lang="en-GB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ve most abundant yRNAs derived from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reads. All L1 ysRNA reads of each replicate were normalised and ranked by abundance. The first column shows the sequence motif of the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whereas the second column gives the abundance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ve least abundant yRNAs derived from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reads. All L1 ysRNA reads of each replicate were normalised and ranked by abundance. The first column shows the sequence motif of the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whereas in the second column the abundance is depicted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ve most abundant Y RNA structures derived from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s (in red) with cleavage site (red arrow). Secondary structure was generated using RNAfold and Varna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ve least abundant Y RNA structures derived from L1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s (in red) generate less or no ysRNAs. Secondary structure was generated using RNAfold and Varna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4307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9</TotalTime>
  <Words>240</Words>
  <Application>Microsoft Office PowerPoint</Application>
  <PresentationFormat>Custom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 - Staff)</dc:creator>
  <cp:lastModifiedBy>Darrell Green (MED - Staff)</cp:lastModifiedBy>
  <cp:revision>55</cp:revision>
  <cp:lastPrinted>2021-04-18T17:09:55Z</cp:lastPrinted>
  <dcterms:created xsi:type="dcterms:W3CDTF">2021-02-23T16:13:42Z</dcterms:created>
  <dcterms:modified xsi:type="dcterms:W3CDTF">2021-09-23T10:54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907393687</vt:i4>
  </property>
  <property fmtid="{D5CDD505-2E9C-101B-9397-08002B2CF9AE}" pid="3" name="_NewReviewCycle">
    <vt:lpwstr/>
  </property>
  <property fmtid="{D5CDD505-2E9C-101B-9397-08002B2CF9AE}" pid="4" name="_EmailSubject">
    <vt:lpwstr>RNA Biology - Manuscript ID KRNB-2021-0491R3</vt:lpwstr>
  </property>
  <property fmtid="{D5CDD505-2E9C-101B-9397-08002B2CF9AE}" pid="5" name="_AuthorEmail">
    <vt:lpwstr>D.Green@uea.ac.uk</vt:lpwstr>
  </property>
  <property fmtid="{D5CDD505-2E9C-101B-9397-08002B2CF9AE}" pid="6" name="_AuthorEmailDisplayName">
    <vt:lpwstr>Darrell Green (MED - Staff)</vt:lpwstr>
  </property>
  <property fmtid="{D5CDD505-2E9C-101B-9397-08002B2CF9AE}" pid="7" name="_PreviousAdHocReviewCycleID">
    <vt:i4>415620094</vt:i4>
  </property>
</Properties>
</file>